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8" autoAdjust="0"/>
    <p:restoredTop sz="94660"/>
  </p:normalViewPr>
  <p:slideViewPr>
    <p:cSldViewPr snapToGrid="0">
      <p:cViewPr varScale="1">
        <p:scale>
          <a:sx n="77" d="100"/>
          <a:sy n="77" d="100"/>
        </p:scale>
        <p:origin x="306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49888;&#52404;&#54876;&#46041;\PAF&#50836;&#51064;&#48324;&#44536;&#47548;&#44536;&#47532;&#44592;_DPA_Soseul_24062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49888;&#52404;&#54876;&#46041;\PAF&#50836;&#51064;&#48324;&#44536;&#47548;&#44536;&#47532;&#44592;_DPA_Soseul_240625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49888;&#52404;&#54876;&#46041;\PAF&#50836;&#51064;&#48324;&#44536;&#47548;&#44536;&#47532;&#44592;_DPA_Soseul_240625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49888;&#52404;&#54876;&#46041;\PAF&#50836;&#51064;&#48324;&#44536;&#47548;&#44536;&#47532;&#44592;_DPA_Soseul_240625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49888;&#52404;&#54876;&#46041;\PAF&#50836;&#51064;&#48324;&#44536;&#47548;&#44536;&#47532;&#44592;_DPA_Soseul_240625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49888;&#52404;&#54876;&#46041;\PAF&#50836;&#51064;&#48324;&#44536;&#47548;&#44536;&#47532;&#44592;_DPA_Soseul_240625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DE51-44EB-AE6C-F2F93CD10642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DE51-44EB-AE6C-F2F93CD10642}"/>
              </c:ext>
            </c:extLst>
          </c:dPt>
          <c:dLbls>
            <c:dLbl>
              <c:idx val="0"/>
              <c:layout>
                <c:manualLayout>
                  <c:x val="-3.3193595569098906E-3"/>
                  <c:y val="3.6377559249454128E-2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DE51-44EB-AE6C-F2F93CD10642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DE51-44EB-AE6C-F2F93CD10642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15_D!$A$1:$A$2</c:f>
              <c:strCache>
                <c:ptCount val="2"/>
                <c:pt idx="0">
                  <c:v>Others</c:v>
                </c:pt>
                <c:pt idx="1">
                  <c:v>DPA</c:v>
                </c:pt>
              </c:strCache>
            </c:strRef>
          </c:cat>
          <c:val>
            <c:numRef>
              <c:f>남녀_2015_D!$B$1:$B$2</c:f>
              <c:numCache>
                <c:formatCode>General</c:formatCode>
                <c:ptCount val="2"/>
                <c:pt idx="0">
                  <c:v>99.3</c:v>
                </c:pt>
                <c:pt idx="1">
                  <c:v>0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E51-44EB-AE6C-F2F93CD10642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3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6A82-4C2E-962C-C18AB482B79A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6A82-4C2E-962C-C18AB482B79A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6A82-4C2E-962C-C18AB482B79A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90F94388-9288-4D39-9232-E81D835958E9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6A82-4C2E-962C-C18AB482B79A}"/>
                </c:ext>
              </c:extLst>
            </c:dLbl>
            <c:dLbl>
              <c:idx val="1"/>
              <c:layout>
                <c:manualLayout>
                  <c:x val="3.9303047709431167E-2"/>
                  <c:y val="-8.2719711200008005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6A82-4C2E-962C-C18AB482B79A}"/>
                </c:ext>
              </c:extLst>
            </c:dLbl>
            <c:dLbl>
              <c:idx val="2"/>
              <c:layout>
                <c:manualLayout>
                  <c:x val="0"/>
                  <c:y val="-1.55746859845914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6A82-4C2E-962C-C18AB482B79A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15_D!$A$5:$A$7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남녀_2015_D!$B$5:$B$7</c:f>
              <c:numCache>
                <c:formatCode>General</c:formatCode>
                <c:ptCount val="3"/>
                <c:pt idx="0">
                  <c:v>454</c:v>
                </c:pt>
                <c:pt idx="1">
                  <c:v>66</c:v>
                </c:pt>
                <c:pt idx="2">
                  <c:v>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A82-4C2E-962C-C18AB482B79A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9AC1-41DC-B847-68E2CF3C93CE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9AC1-41DC-B847-68E2CF3C93CE}"/>
              </c:ext>
            </c:extLst>
          </c:dPt>
          <c:dLbls>
            <c:dLbl>
              <c:idx val="0"/>
              <c:layout>
                <c:manualLayout>
                  <c:x val="-3.6150229251468271E-3"/>
                  <c:y val="3.3307659802743368E-2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9AC1-41DC-B847-68E2CF3C93CE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156896386589221"/>
                      <c:h val="0.12833511193168262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9AC1-41DC-B847-68E2CF3C93CE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15_D!$A$1:$A$2</c:f>
              <c:strCache>
                <c:ptCount val="2"/>
                <c:pt idx="0">
                  <c:v>Others</c:v>
                </c:pt>
                <c:pt idx="1">
                  <c:v>DPA</c:v>
                </c:pt>
              </c:strCache>
            </c:strRef>
          </c:cat>
          <c:val>
            <c:numRef>
              <c:f>남자_2015_D!$B$1:$B$2</c:f>
              <c:numCache>
                <c:formatCode>General</c:formatCode>
                <c:ptCount val="2"/>
                <c:pt idx="0">
                  <c:v>99.8</c:v>
                </c:pt>
                <c:pt idx="1">
                  <c:v>0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AC1-41DC-B847-68E2CF3C93CE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2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F014-4788-8CE4-498E9B9C7274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4FC9A4F7-34E4-49DA-A358-CFC436E1648B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F014-4788-8CE4-498E9B9C7274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15_D!$A$5</c:f>
              <c:strCache>
                <c:ptCount val="1"/>
                <c:pt idx="0">
                  <c:v>Colorectal</c:v>
                </c:pt>
              </c:strCache>
            </c:strRef>
          </c:cat>
          <c:val>
            <c:numRef>
              <c:f>남자_2015_D!$B$5</c:f>
              <c:numCache>
                <c:formatCode>General</c:formatCode>
                <c:ptCount val="1"/>
                <c:pt idx="0">
                  <c:v>1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014-4788-8CE4-498E9B9C7274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0EB9-42A6-89B8-C9AD43BAEFAC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0EB9-42A6-89B8-C9AD43BAEFAC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0EB9-42A6-89B8-C9AD43BAEFAC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0EB9-42A6-89B8-C9AD43BAEFAC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15_D!$A$1:$A$2</c:f>
              <c:strCache>
                <c:ptCount val="2"/>
                <c:pt idx="0">
                  <c:v>Others</c:v>
                </c:pt>
                <c:pt idx="1">
                  <c:v>DPA</c:v>
                </c:pt>
              </c:strCache>
            </c:strRef>
          </c:cat>
          <c:val>
            <c:numRef>
              <c:f>여자_2015_D!$B$1:$B$2</c:f>
              <c:numCache>
                <c:formatCode>General</c:formatCode>
                <c:ptCount val="2"/>
                <c:pt idx="0">
                  <c:v>98.6</c:v>
                </c:pt>
                <c:pt idx="1">
                  <c:v>1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EB9-42A6-89B8-C9AD43BAEFAC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3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21A8-481A-8406-6D3B40BFD4B3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21A8-481A-8406-6D3B40BFD4B3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21A8-481A-8406-6D3B40BFD4B3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72DE87BD-D998-41D5-A1DB-FCEAE9B5F849}" type="PERCENTAG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21A8-481A-8406-6D3B40BFD4B3}"/>
                </c:ext>
              </c:extLst>
            </c:dLbl>
            <c:dLbl>
              <c:idx val="1"/>
              <c:layout>
                <c:manualLayout>
                  <c:x val="-2.6501826793594297E-2"/>
                  <c:y val="0.10272760458445165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21A8-481A-8406-6D3B40BFD4B3}"/>
                </c:ext>
              </c:extLst>
            </c:dLbl>
            <c:dLbl>
              <c:idx val="2"/>
              <c:layout>
                <c:manualLayout>
                  <c:x val="0"/>
                  <c:y val="-1.55746859845914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21A8-481A-8406-6D3B40BFD4B3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15_D!$A$5:$A$7</c:f>
              <c:strCache>
                <c:ptCount val="3"/>
                <c:pt idx="0">
                  <c:v>Colorectal</c:v>
                </c:pt>
                <c:pt idx="1">
                  <c:v>Breast</c:v>
                </c:pt>
                <c:pt idx="2">
                  <c:v>Corpus uteri</c:v>
                </c:pt>
              </c:strCache>
            </c:strRef>
          </c:cat>
          <c:val>
            <c:numRef>
              <c:f>여자_2015_D!$B$5:$B$7</c:f>
              <c:numCache>
                <c:formatCode>General</c:formatCode>
                <c:ptCount val="3"/>
                <c:pt idx="0">
                  <c:v>345</c:v>
                </c:pt>
                <c:pt idx="1">
                  <c:v>66</c:v>
                </c:pt>
                <c:pt idx="2">
                  <c:v>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1A8-481A-8406-6D3B40BFD4B3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02889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4184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7110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7356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48971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4662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0927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8824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046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3655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13221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F6322-D1F5-449B-AF1C-C65DD1C8A288}" type="datetimeFigureOut">
              <a:rPr lang="ko-KR" altLang="en-US" smtClean="0"/>
              <a:t>2025-09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10F9C-5917-4025-91E3-EB32309D47B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4248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88DD15CE-8E38-4711-B493-E1FAD784A8FF}"/>
              </a:ext>
            </a:extLst>
          </p:cNvPr>
          <p:cNvGrpSpPr/>
          <p:nvPr/>
        </p:nvGrpSpPr>
        <p:grpSpPr>
          <a:xfrm>
            <a:off x="489648" y="328291"/>
            <a:ext cx="5827904" cy="9401819"/>
            <a:chOff x="407645" y="620837"/>
            <a:chExt cx="5827904" cy="9401819"/>
          </a:xfrm>
        </p:grpSpPr>
        <p:sp>
          <p:nvSpPr>
            <p:cNvPr id="53" name="직사각형 52">
              <a:extLst>
                <a:ext uri="{FF2B5EF4-FFF2-40B4-BE49-F238E27FC236}">
                  <a16:creationId xmlns:a16="http://schemas.microsoft.com/office/drawing/2014/main" id="{E9FFEC05-C143-45B5-A6AA-E9F7914DFFBF}"/>
                </a:ext>
              </a:extLst>
            </p:cNvPr>
            <p:cNvSpPr/>
            <p:nvPr/>
          </p:nvSpPr>
          <p:spPr>
            <a:xfrm>
              <a:off x="468297" y="9468658"/>
              <a:ext cx="5630400" cy="553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Material 8. The population attributable fraction (%) of cancer deaths attributed to deficit in physical activity and proportion of specific cancers among all-cancer deaths caused by deficit in physical activity in Korea, 2015.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" name="그룹 8">
              <a:extLst>
                <a:ext uri="{FF2B5EF4-FFF2-40B4-BE49-F238E27FC236}">
                  <a16:creationId xmlns:a16="http://schemas.microsoft.com/office/drawing/2014/main" id="{5BEBB4CB-0299-49A1-945F-9612EE8C6793}"/>
                </a:ext>
              </a:extLst>
            </p:cNvPr>
            <p:cNvGrpSpPr/>
            <p:nvPr/>
          </p:nvGrpSpPr>
          <p:grpSpPr>
            <a:xfrm>
              <a:off x="407645" y="620837"/>
              <a:ext cx="5827904" cy="8816450"/>
              <a:chOff x="515254" y="620837"/>
              <a:chExt cx="5827904" cy="8816450"/>
            </a:xfrm>
          </p:grpSpPr>
          <p:grpSp>
            <p:nvGrpSpPr>
              <p:cNvPr id="6" name="그룹 5">
                <a:extLst>
                  <a:ext uri="{FF2B5EF4-FFF2-40B4-BE49-F238E27FC236}">
                    <a16:creationId xmlns:a16="http://schemas.microsoft.com/office/drawing/2014/main" id="{13F1AD63-C9FA-424A-9001-C842BF544CB2}"/>
                  </a:ext>
                </a:extLst>
              </p:cNvPr>
              <p:cNvGrpSpPr/>
              <p:nvPr/>
            </p:nvGrpSpPr>
            <p:grpSpPr>
              <a:xfrm>
                <a:off x="515254" y="620837"/>
                <a:ext cx="5827492" cy="3169148"/>
                <a:chOff x="515254" y="620837"/>
                <a:chExt cx="5827492" cy="3169148"/>
              </a:xfrm>
            </p:grpSpPr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ED0E3951-E7A8-4D37-953A-49C87951C1DC}"/>
                    </a:ext>
                  </a:extLst>
                </p:cNvPr>
                <p:cNvSpPr txBox="1"/>
                <p:nvPr/>
              </p:nvSpPr>
              <p:spPr>
                <a:xfrm>
                  <a:off x="515254" y="620837"/>
                  <a:ext cx="158248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otal cancer deaths, 2015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54" name="그룹 53">
                  <a:extLst>
                    <a:ext uri="{FF2B5EF4-FFF2-40B4-BE49-F238E27FC236}">
                      <a16:creationId xmlns:a16="http://schemas.microsoft.com/office/drawing/2014/main" id="{58607E6C-0B0D-4681-B41B-3693E48E1BC6}"/>
                    </a:ext>
                  </a:extLst>
                </p:cNvPr>
                <p:cNvGrpSpPr/>
                <p:nvPr/>
              </p:nvGrpSpPr>
              <p:grpSpPr>
                <a:xfrm>
                  <a:off x="647632" y="649148"/>
                  <a:ext cx="5695114" cy="3140837"/>
                  <a:chOff x="0" y="0"/>
                  <a:chExt cx="5718560" cy="2997229"/>
                </a:xfrm>
              </p:grpSpPr>
              <p:grpSp>
                <p:nvGrpSpPr>
                  <p:cNvPr id="55" name="그룹 54">
                    <a:extLst>
                      <a:ext uri="{FF2B5EF4-FFF2-40B4-BE49-F238E27FC236}">
                        <a16:creationId xmlns:a16="http://schemas.microsoft.com/office/drawing/2014/main" id="{EBC612EE-108A-43AC-849C-5700EAB1AB33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18560" cy="2997229"/>
                    <a:chOff x="0" y="0"/>
                    <a:chExt cx="6113798" cy="3579573"/>
                  </a:xfrm>
                </p:grpSpPr>
                <p:grpSp>
                  <p:nvGrpSpPr>
                    <p:cNvPr id="57" name="그룹 56">
                      <a:extLst>
                        <a:ext uri="{FF2B5EF4-FFF2-40B4-BE49-F238E27FC236}">
                          <a16:creationId xmlns:a16="http://schemas.microsoft.com/office/drawing/2014/main" id="{B693BC21-22EF-4760-A5F5-3DA04D9E27D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6113798" cy="3579573"/>
                      <a:chOff x="0" y="0"/>
                      <a:chExt cx="11105321" cy="4138820"/>
                    </a:xfrm>
                  </p:grpSpPr>
                  <p:graphicFrame>
                    <p:nvGraphicFramePr>
                      <p:cNvPr id="59" name="차트 58">
                        <a:extLst>
                          <a:ext uri="{FF2B5EF4-FFF2-40B4-BE49-F238E27FC236}">
                            <a16:creationId xmlns:a16="http://schemas.microsoft.com/office/drawing/2014/main" id="{34E4E720-7671-4061-955A-5B51F6C57A3A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2"/>
                      </a:graphicData>
                    </a:graphic>
                  </p:graphicFrame>
                  <p:graphicFrame>
                    <p:nvGraphicFramePr>
                      <p:cNvPr id="60" name="차트 59">
                        <a:extLst>
                          <a:ext uri="{FF2B5EF4-FFF2-40B4-BE49-F238E27FC236}">
                            <a16:creationId xmlns:a16="http://schemas.microsoft.com/office/drawing/2014/main" id="{719CD4F4-0FB0-42E4-97E5-6BFDFBCAEC4D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5273415" y="0"/>
                      <a:ext cx="5831906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3"/>
                      </a:graphicData>
                    </a:graphic>
                  </p:graphicFrame>
                </p:grpSp>
                <p:cxnSp>
                  <p:nvCxnSpPr>
                    <p:cNvPr id="58" name="직선 연결선 57">
                      <a:extLst>
                        <a:ext uri="{FF2B5EF4-FFF2-40B4-BE49-F238E27FC236}">
                          <a16:creationId xmlns:a16="http://schemas.microsoft.com/office/drawing/2014/main" id="{607AA6A5-271F-4BA5-B485-E2233694A1DF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242436" y="1988688"/>
                      <a:ext cx="1971940" cy="1247884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56" name="직선 연결선 55">
                    <a:extLst>
                      <a:ext uri="{FF2B5EF4-FFF2-40B4-BE49-F238E27FC236}">
                        <a16:creationId xmlns:a16="http://schemas.microsoft.com/office/drawing/2014/main" id="{510045CB-47FC-4F4A-9B4D-5300B368FCB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73927" y="285752"/>
                    <a:ext cx="1820415" cy="1122103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7" name="그룹 6">
                <a:extLst>
                  <a:ext uri="{FF2B5EF4-FFF2-40B4-BE49-F238E27FC236}">
                    <a16:creationId xmlns:a16="http://schemas.microsoft.com/office/drawing/2014/main" id="{9243BB98-B06D-471F-B264-882ECE401C2E}"/>
                  </a:ext>
                </a:extLst>
              </p:cNvPr>
              <p:cNvGrpSpPr/>
              <p:nvPr/>
            </p:nvGrpSpPr>
            <p:grpSpPr>
              <a:xfrm>
                <a:off x="515254" y="3571297"/>
                <a:ext cx="5827492" cy="3042341"/>
                <a:chOff x="515254" y="3571297"/>
                <a:chExt cx="5827492" cy="3042341"/>
              </a:xfrm>
            </p:grpSpPr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258A911A-63B4-40A6-978C-8464EFBD17F1}"/>
                    </a:ext>
                  </a:extLst>
                </p:cNvPr>
                <p:cNvSpPr txBox="1"/>
                <p:nvPr/>
              </p:nvSpPr>
              <p:spPr>
                <a:xfrm>
                  <a:off x="515254" y="3681480"/>
                  <a:ext cx="156966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le cancer deaths, 2015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68" name="그룹 67">
                  <a:extLst>
                    <a:ext uri="{FF2B5EF4-FFF2-40B4-BE49-F238E27FC236}">
                      <a16:creationId xmlns:a16="http://schemas.microsoft.com/office/drawing/2014/main" id="{2B684D4C-1404-48A1-BFEC-23FB3F60E12A}"/>
                    </a:ext>
                  </a:extLst>
                </p:cNvPr>
                <p:cNvGrpSpPr/>
                <p:nvPr/>
              </p:nvGrpSpPr>
              <p:grpSpPr>
                <a:xfrm>
                  <a:off x="621540" y="3571297"/>
                  <a:ext cx="5721206" cy="3042341"/>
                  <a:chOff x="0" y="0"/>
                  <a:chExt cx="5717829" cy="3298744"/>
                </a:xfrm>
              </p:grpSpPr>
              <p:grpSp>
                <p:nvGrpSpPr>
                  <p:cNvPr id="69" name="그룹 68">
                    <a:extLst>
                      <a:ext uri="{FF2B5EF4-FFF2-40B4-BE49-F238E27FC236}">
                        <a16:creationId xmlns:a16="http://schemas.microsoft.com/office/drawing/2014/main" id="{299AA2CC-3950-461C-8190-74348785B547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17829" cy="3298744"/>
                    <a:chOff x="0" y="0"/>
                    <a:chExt cx="5695116" cy="3251851"/>
                  </a:xfrm>
                </p:grpSpPr>
                <p:grpSp>
                  <p:nvGrpSpPr>
                    <p:cNvPr id="71" name="그룹 70">
                      <a:extLst>
                        <a:ext uri="{FF2B5EF4-FFF2-40B4-BE49-F238E27FC236}">
                          <a16:creationId xmlns:a16="http://schemas.microsoft.com/office/drawing/2014/main" id="{E222DE7A-3B36-42AB-B83B-9142755F496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0"/>
                      <a:ext cx="5695116" cy="3251851"/>
                      <a:chOff x="0" y="0"/>
                      <a:chExt cx="11105322" cy="4138820"/>
                    </a:xfrm>
                  </p:grpSpPr>
                  <p:graphicFrame>
                    <p:nvGraphicFramePr>
                      <p:cNvPr id="73" name="차트 72">
                        <a:extLst>
                          <a:ext uri="{FF2B5EF4-FFF2-40B4-BE49-F238E27FC236}">
                            <a16:creationId xmlns:a16="http://schemas.microsoft.com/office/drawing/2014/main" id="{E1E71A11-52A3-49D5-AE89-E1C435F409B4}"/>
                          </a:ext>
                        </a:extLst>
                      </p:cNvPr>
                      <p:cNvGraphicFramePr>
                        <a:graphicFrameLocks/>
                      </p:cNvGraphicFramePr>
                      <p:nvPr>
                        <p:extLst>
                          <p:ext uri="{D42A27DB-BD31-4B8C-83A1-F6EECF244321}">
                            <p14:modId xmlns:p14="http://schemas.microsoft.com/office/powerpoint/2010/main" val="3575333269"/>
                          </p:ext>
                        </p:extLst>
                      </p:nvPr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4"/>
                      </a:graphicData>
                    </a:graphic>
                  </p:graphicFrame>
                  <p:graphicFrame>
                    <p:nvGraphicFramePr>
                      <p:cNvPr id="74" name="차트 73">
                        <a:extLst>
                          <a:ext uri="{FF2B5EF4-FFF2-40B4-BE49-F238E27FC236}">
                            <a16:creationId xmlns:a16="http://schemas.microsoft.com/office/drawing/2014/main" id="{B9100564-E3EB-4BF0-9116-C35BCF467B64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5273413" y="0"/>
                      <a:ext cx="5831909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5"/>
                      </a:graphicData>
                    </a:graphic>
                  </p:graphicFrame>
                </p:grpSp>
                <p:cxnSp>
                  <p:nvCxnSpPr>
                    <p:cNvPr id="72" name="직선 연결선 71">
                      <a:extLst>
                        <a:ext uri="{FF2B5EF4-FFF2-40B4-BE49-F238E27FC236}">
                          <a16:creationId xmlns:a16="http://schemas.microsoft.com/office/drawing/2014/main" id="{1AD827C1-B2E5-4F3F-B819-C86EFBEE864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028680" y="1852289"/>
                      <a:ext cx="1752094" cy="1030081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70" name="직선 연결선 69">
                    <a:extLst>
                      <a:ext uri="{FF2B5EF4-FFF2-40B4-BE49-F238E27FC236}">
                        <a16:creationId xmlns:a16="http://schemas.microsoft.com/office/drawing/2014/main" id="{86B03D39-1FD7-474E-BC53-467AFA8DF02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53141" y="470931"/>
                    <a:ext cx="1623675" cy="1060884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8" name="그룹 7">
                <a:extLst>
                  <a:ext uri="{FF2B5EF4-FFF2-40B4-BE49-F238E27FC236}">
                    <a16:creationId xmlns:a16="http://schemas.microsoft.com/office/drawing/2014/main" id="{82C1341E-4CE4-4689-BC87-D1DA72A5CE03}"/>
                  </a:ext>
                </a:extLst>
              </p:cNvPr>
              <p:cNvGrpSpPr/>
              <p:nvPr/>
            </p:nvGrpSpPr>
            <p:grpSpPr>
              <a:xfrm>
                <a:off x="515254" y="6394950"/>
                <a:ext cx="5827904" cy="3042337"/>
                <a:chOff x="515254" y="6394950"/>
                <a:chExt cx="5827904" cy="3042337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1CCE139B-33F4-42FE-852F-5255F617D6FF}"/>
                    </a:ext>
                  </a:extLst>
                </p:cNvPr>
                <p:cNvSpPr txBox="1"/>
                <p:nvPr/>
              </p:nvSpPr>
              <p:spPr>
                <a:xfrm>
                  <a:off x="515254" y="6538005"/>
                  <a:ext cx="17187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emale cancer deaths, 2015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75" name="그룹 74">
                  <a:extLst>
                    <a:ext uri="{FF2B5EF4-FFF2-40B4-BE49-F238E27FC236}">
                      <a16:creationId xmlns:a16="http://schemas.microsoft.com/office/drawing/2014/main" id="{EAD1DD17-5AB5-4298-9592-F5518D614DB3}"/>
                    </a:ext>
                  </a:extLst>
                </p:cNvPr>
                <p:cNvGrpSpPr/>
                <p:nvPr/>
              </p:nvGrpSpPr>
              <p:grpSpPr>
                <a:xfrm>
                  <a:off x="621540" y="6394950"/>
                  <a:ext cx="5721618" cy="3042337"/>
                  <a:chOff x="0" y="0"/>
                  <a:chExt cx="5708367" cy="3214577"/>
                </a:xfrm>
              </p:grpSpPr>
              <p:grpSp>
                <p:nvGrpSpPr>
                  <p:cNvPr id="76" name="그룹 75">
                    <a:extLst>
                      <a:ext uri="{FF2B5EF4-FFF2-40B4-BE49-F238E27FC236}">
                        <a16:creationId xmlns:a16="http://schemas.microsoft.com/office/drawing/2014/main" id="{E3B9838C-9B46-4330-8FC8-F7A65BE57083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08367" cy="3214577"/>
                    <a:chOff x="0" y="0"/>
                    <a:chExt cx="11105322" cy="4138820"/>
                  </a:xfrm>
                </p:grpSpPr>
                <p:graphicFrame>
                  <p:nvGraphicFramePr>
                    <p:cNvPr id="79" name="차트 78">
                      <a:extLst>
                        <a:ext uri="{FF2B5EF4-FFF2-40B4-BE49-F238E27FC236}">
                          <a16:creationId xmlns:a16="http://schemas.microsoft.com/office/drawing/2014/main" id="{61CFFCCE-35F5-4422-B1ED-C9CD99CE6D1E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0" y="652478"/>
                    <a:ext cx="4681538" cy="2833864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6"/>
                    </a:graphicData>
                  </a:graphic>
                </p:graphicFrame>
                <p:graphicFrame>
                  <p:nvGraphicFramePr>
                    <p:cNvPr id="80" name="차트 79">
                      <a:extLst>
                        <a:ext uri="{FF2B5EF4-FFF2-40B4-BE49-F238E27FC236}">
                          <a16:creationId xmlns:a16="http://schemas.microsoft.com/office/drawing/2014/main" id="{7A3D6B9A-AE9E-4576-A673-E5B9ACFBFC98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5273414" y="0"/>
                    <a:ext cx="5831908" cy="413882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7"/>
                    </a:graphicData>
                  </a:graphic>
                </p:graphicFrame>
              </p:grpSp>
              <p:cxnSp>
                <p:nvCxnSpPr>
                  <p:cNvPr id="77" name="직선 연결선 76">
                    <a:extLst>
                      <a:ext uri="{FF2B5EF4-FFF2-40B4-BE49-F238E27FC236}">
                        <a16:creationId xmlns:a16="http://schemas.microsoft.com/office/drawing/2014/main" id="{22BB42CA-5AB0-4C83-9BFA-F5355DF05AA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80758" y="339090"/>
                    <a:ext cx="1769954" cy="1101287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8" name="직선 연결선 77">
                    <a:extLst>
                      <a:ext uri="{FF2B5EF4-FFF2-40B4-BE49-F238E27FC236}">
                        <a16:creationId xmlns:a16="http://schemas.microsoft.com/office/drawing/2014/main" id="{83F3D7F9-3D03-46F5-9114-79439177B3E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95386" y="1747669"/>
                    <a:ext cx="1784582" cy="1149260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</p:grpSp>
    </p:spTree>
    <p:extLst>
      <p:ext uri="{BB962C8B-B14F-4D97-AF65-F5344CB8AC3E}">
        <p14:creationId xmlns:p14="http://schemas.microsoft.com/office/powerpoint/2010/main" val="2737180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4</TotalTime>
  <Words>85</Words>
  <Application>Microsoft Office PowerPoint</Application>
  <PresentationFormat>A4 용지(210x297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seul Sung</dc:creator>
  <cp:lastModifiedBy>이제인</cp:lastModifiedBy>
  <cp:revision>130</cp:revision>
  <dcterms:created xsi:type="dcterms:W3CDTF">2024-07-11T07:58:49Z</dcterms:created>
  <dcterms:modified xsi:type="dcterms:W3CDTF">2025-09-25T00:27:08Z</dcterms:modified>
</cp:coreProperties>
</file>